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4D10B-A52E-4560-BF54-2519CA07E6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07990-6BBE-4672-8293-29ED17E1C8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593E4-A0CF-4198-9790-DBFB7E4B70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2CC030-058A-4FC4-B2C6-B0787DFFB5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FA645A-CF63-4161-9585-F8BD6F81C8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2E1C0-0905-47BC-938F-871B376BA6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4F32F-B3A2-4CEC-9CEE-245400A473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D613F-2B56-464B-8496-C0CE29C666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7667C-CBC4-4E40-B97D-E5C88325EC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0A07D-DA78-43F0-AC81-8C4EFB0F9F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774F5-A631-4E83-9B82-DA9549F83B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4B38D-83C8-4034-ACD1-DEF6E6DE1B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C95F885-B424-4AF4-AB4B-D78F3AADCB4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62120" y="789120"/>
          <a:ext cx="3676680" cy="4713120"/>
        </p:xfrm>
        <a:graphic>
          <a:graphicData uri="http://schemas.openxmlformats.org/drawingml/2006/table">
            <a:tbl>
              <a:tblPr/>
              <a:tblGrid>
                <a:gridCol w="820440"/>
                <a:gridCol w="1532160"/>
                <a:gridCol w="1324080"/>
              </a:tblGrid>
              <a:tr h="176400">
                <a:tc gridSpan="3">
                  <a:txBody>
                    <a:bodyPr lIns="7920" rIns="7920" tIns="75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imers </a:t>
                      </a: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d probes used in qRT-PCR experimen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59120">
                <a:tc>
                  <a:txBody>
                    <a:bodyPr lIns="7920" rIns="792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ligo 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quence 5' to 3'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difica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592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s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GTCCTATTCCATTATTCCTAGC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6-FAM], 3'[BHQ-1]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s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TGCTCTTAGCTGAG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98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s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CGAAAACCAACAAAAT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PDH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AGATCATCAGCAATGCCTC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5TET], 3'[BHQ-1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PDH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ACCATGAGAAGTATGAC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PDH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GTCCTTCCACGATA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Actin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TGGACATCCGCAAAGA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AminoC6+TxRed], 3'[BHQ-2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Actin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TCCACGAAACTACCT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Actin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AGTGATCTCCTTC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ubulin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ACAACTCCATCCTCACCA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Cy5], 3'[BHQ-3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ubulin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CACAGCTGTAGTTG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ubulin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GACGCTCAATATCG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300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FAM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CTGTGCCTATCCAT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6-FAM], 3'[BHQ-1]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FAM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CAATAAAGAAACA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FAM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TTTACGATAGCTTC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RF1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CGAGTAGTATATTCATCTAAC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5TET], 3'[BHQ-1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RF1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ATTTGAGTCTAATCC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02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RF1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ATACAGAGGACAAT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GC-1a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TTCGCTTTATTGCTC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AminoC6+TxRed], 3'[BHQ-2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GC-1a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TAAGTTATAATGAAT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GC-1a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TTTGCTGTTGACAA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FB1M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ATCTGAGTTCTGCCAT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Cy5], 3'[BHQ-3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FB1M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AATCTGCCTTTTAG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FB1M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TCCTTTTGAAAAGT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2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CGCAAGCAACCGCATCCATA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6-FAM], 3'[BHQ-1]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2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GCTGCCATCAAGTATTT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2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AGTATTGGTTATGGTTCATTG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X3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AAGCCGCCGCCTGATAC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5TET], 3'[BHQ-1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X3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TCACTTTACATCCAAACATC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98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X3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ATAGATGGAGACATACAGAAAT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4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CAGAACGCCTGAACGC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AminoC6+TxRed], 3'[BHQ-2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4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GCTATCATCACCCGA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D4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GTAGTAGAATGTTTAGTGA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1844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s prob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CCAGAACACTACGAGCCAC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[dQuasara670], 3'[BHQ-3]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1808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s 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TCAACAGTTAAATCAACAAA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8720"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s antisen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GAGCAAGAGGTGGTG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5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3T13:40:15Z</dcterms:created>
  <dc:creator>Emily Cronin-Furman</dc:creator>
  <dc:description/>
  <dc:language>en-US</dc:language>
  <cp:lastModifiedBy>Pat Trimmer</cp:lastModifiedBy>
  <dcterms:modified xsi:type="dcterms:W3CDTF">2012-12-11T20:34:28Z</dcterms:modified>
  <cp:revision>2</cp:revision>
  <dc:subject/>
  <dc:title>PowerPoint Presentation</dc:title>
</cp:coreProperties>
</file>